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01" d="100"/>
          <a:sy n="101" d="100"/>
        </p:scale>
        <p:origin x="-108" y="-23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52C5C-0E77-974F-9B9F-8EAF11917089}" type="datetimeFigureOut">
              <a:rPr lang="es-ES" smtClean="0"/>
              <a:pPr/>
              <a:t>04/04/20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CC6A3-4ED1-C948-AE98-F22753EDF534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31781858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52C5C-0E77-974F-9B9F-8EAF11917089}" type="datetimeFigureOut">
              <a:rPr lang="es-ES" smtClean="0"/>
              <a:pPr/>
              <a:t>04/04/20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CC6A3-4ED1-C948-AE98-F22753EDF534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31692628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52C5C-0E77-974F-9B9F-8EAF11917089}" type="datetimeFigureOut">
              <a:rPr lang="es-ES" smtClean="0"/>
              <a:pPr/>
              <a:t>04/04/20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CC6A3-4ED1-C948-AE98-F22753EDF534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42400333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52C5C-0E77-974F-9B9F-8EAF11917089}" type="datetimeFigureOut">
              <a:rPr lang="es-ES" smtClean="0"/>
              <a:pPr/>
              <a:t>04/04/20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CC6A3-4ED1-C948-AE98-F22753EDF534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26985610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52C5C-0E77-974F-9B9F-8EAF11917089}" type="datetimeFigureOut">
              <a:rPr lang="es-ES" smtClean="0"/>
              <a:pPr/>
              <a:t>04/04/20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CC6A3-4ED1-C948-AE98-F22753EDF534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22298326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52C5C-0E77-974F-9B9F-8EAF11917089}" type="datetimeFigureOut">
              <a:rPr lang="es-ES" smtClean="0"/>
              <a:pPr/>
              <a:t>04/04/2018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CC6A3-4ED1-C948-AE98-F22753EDF534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2174721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52C5C-0E77-974F-9B9F-8EAF11917089}" type="datetimeFigureOut">
              <a:rPr lang="es-ES" smtClean="0"/>
              <a:pPr/>
              <a:t>04/04/2018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CC6A3-4ED1-C948-AE98-F22753EDF534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7578704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52C5C-0E77-974F-9B9F-8EAF11917089}" type="datetimeFigureOut">
              <a:rPr lang="es-ES" smtClean="0"/>
              <a:pPr/>
              <a:t>04/04/2018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CC6A3-4ED1-C948-AE98-F22753EDF534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33248772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52C5C-0E77-974F-9B9F-8EAF11917089}" type="datetimeFigureOut">
              <a:rPr lang="es-ES" smtClean="0"/>
              <a:pPr/>
              <a:t>04/04/2018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CC6A3-4ED1-C948-AE98-F22753EDF534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12917256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52C5C-0E77-974F-9B9F-8EAF11917089}" type="datetimeFigureOut">
              <a:rPr lang="es-ES" smtClean="0"/>
              <a:pPr/>
              <a:t>04/04/2018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CC6A3-4ED1-C948-AE98-F22753EDF534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30016279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52C5C-0E77-974F-9B9F-8EAF11917089}" type="datetimeFigureOut">
              <a:rPr lang="es-ES" smtClean="0"/>
              <a:pPr/>
              <a:t>04/04/2018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CC6A3-4ED1-C948-AE98-F22753EDF534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37828359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F52C5C-0E77-974F-9B9F-8EAF11917089}" type="datetimeFigureOut">
              <a:rPr lang="es-ES" smtClean="0"/>
              <a:pPr/>
              <a:t>04/04/20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3CC6A3-4ED1-C948-AE98-F22753EDF534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18463406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0771" y="602926"/>
            <a:ext cx="8479692" cy="6167049"/>
          </a:xfrm>
          <a:prstGeom prst="rect">
            <a:avLst/>
          </a:prstGeom>
        </p:spPr>
      </p:pic>
      <p:sp>
        <p:nvSpPr>
          <p:cNvPr id="2" name="CuadroTexto 1"/>
          <p:cNvSpPr txBox="1"/>
          <p:nvPr/>
        </p:nvSpPr>
        <p:spPr>
          <a:xfrm>
            <a:off x="2082521" y="186565"/>
            <a:ext cx="55194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>
                <a:latin typeface="Arial"/>
                <a:cs typeface="Arial"/>
              </a:rPr>
              <a:t>Figure S1: </a:t>
            </a:r>
            <a:r>
              <a:rPr lang="es-ES" b="1" dirty="0" err="1" smtClean="0">
                <a:latin typeface="Arial"/>
                <a:cs typeface="Arial"/>
              </a:rPr>
              <a:t>Screeplot</a:t>
            </a:r>
            <a:r>
              <a:rPr lang="es-ES" b="1" dirty="0" smtClean="0">
                <a:latin typeface="Arial"/>
                <a:cs typeface="Arial"/>
              </a:rPr>
              <a:t> </a:t>
            </a:r>
            <a:r>
              <a:rPr lang="es-ES" b="1" dirty="0" err="1" smtClean="0">
                <a:latin typeface="Arial"/>
                <a:cs typeface="Arial"/>
              </a:rPr>
              <a:t>for</a:t>
            </a:r>
            <a:r>
              <a:rPr lang="es-ES" b="1" dirty="0" smtClean="0">
                <a:latin typeface="Arial"/>
                <a:cs typeface="Arial"/>
              </a:rPr>
              <a:t> multimorbidity </a:t>
            </a:r>
            <a:r>
              <a:rPr lang="es-ES" b="1" dirty="0" err="1" smtClean="0">
                <a:latin typeface="Arial"/>
                <a:cs typeface="Arial"/>
              </a:rPr>
              <a:t>patterns</a:t>
            </a:r>
            <a:endParaRPr lang="es-ES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9650411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a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530176441"/>
              </p:ext>
            </p:extLst>
          </p:nvPr>
        </p:nvGraphicFramePr>
        <p:xfrm>
          <a:off x="339482" y="1055484"/>
          <a:ext cx="8575054" cy="5802516"/>
        </p:xfrm>
        <a:graphic>
          <a:graphicData uri="http://schemas.openxmlformats.org/drawingml/2006/table">
            <a:tbl>
              <a:tblPr/>
              <a:tblGrid>
                <a:gridCol w="2473574"/>
                <a:gridCol w="2116278"/>
                <a:gridCol w="2198733"/>
                <a:gridCol w="1786469"/>
              </a:tblGrid>
              <a:tr h="495941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600" b="1" i="0" u="none" strike="noStrike" noProof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hronic diseases</a:t>
                      </a:r>
                      <a:endParaRPr lang="en-US" sz="1600" b="1" i="0" u="none" strike="noStrike" noProof="0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s-E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es-MX" sz="16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igenvectors</a:t>
                      </a:r>
                      <a:endParaRPr lang="en-US" sz="1600" b="1" i="0" u="none" strike="noStrike" noProof="0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</a:tr>
              <a:tr h="495941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6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omponent 1</a:t>
                      </a:r>
                      <a:endParaRPr lang="nl-NL" sz="16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nl-NL" sz="16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omponent 2</a:t>
                      </a:r>
                      <a:endParaRPr lang="nl-NL" sz="16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nl-NL" sz="16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omponent </a:t>
                      </a:r>
                      <a:r>
                        <a:rPr lang="nl-NL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4773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1" u="none" strike="noStrike" noProof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troke</a:t>
                      </a:r>
                      <a:endParaRPr lang="en-US" sz="1600" b="0" i="1" u="none" strike="noStrike" noProof="0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54729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64956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44376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477344">
                <a:tc>
                  <a:txBody>
                    <a:bodyPr/>
                    <a:lstStyle/>
                    <a:p>
                      <a:pPr algn="ctr" fontAlgn="b"/>
                      <a:r>
                        <a:rPr lang="es-ES" sz="1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Diabetes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20382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65596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4144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477344">
                <a:tc>
                  <a:txBody>
                    <a:bodyPr/>
                    <a:lstStyle/>
                    <a:p>
                      <a:pPr algn="ctr" fontAlgn="b"/>
                      <a:r>
                        <a:rPr lang="es-ES" sz="1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ataracts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26882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703117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14298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477344">
                <a:tc>
                  <a:txBody>
                    <a:bodyPr/>
                    <a:lstStyle/>
                    <a:p>
                      <a:pPr algn="ctr" fontAlgn="b"/>
                      <a:r>
                        <a:rPr lang="es-ES" sz="1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Depression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56169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8012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693348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477344">
                <a:tc>
                  <a:txBody>
                    <a:bodyPr/>
                    <a:lstStyle/>
                    <a:p>
                      <a:pPr algn="ctr" fontAlgn="b"/>
                      <a:r>
                        <a:rPr lang="es-ES" sz="1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Hypertension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3939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26815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10280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477344">
                <a:tc>
                  <a:txBody>
                    <a:bodyPr/>
                    <a:lstStyle/>
                    <a:p>
                      <a:pPr algn="ctr" fontAlgn="b"/>
                      <a:r>
                        <a:rPr lang="es-ES" sz="16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OPD*</a:t>
                      </a:r>
                      <a:endParaRPr lang="es-ES" sz="16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75201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30213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6404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477344">
                <a:tc>
                  <a:txBody>
                    <a:bodyPr/>
                    <a:lstStyle/>
                    <a:p>
                      <a:pPr algn="ctr" fontAlgn="b"/>
                      <a:r>
                        <a:rPr lang="es-ES" sz="1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sthma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86995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52178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08900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477344"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ngina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76215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1668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75063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49594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1" u="none" strike="noStrike" noProof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rthritis</a:t>
                      </a:r>
                      <a:endParaRPr lang="en-US" sz="1600" b="0" i="1" u="none" strike="noStrike" noProof="0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335387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020068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.02201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495941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1050" b="0" i="1" u="none" strike="noStrike" noProof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*Chronic obstructive pulmonary disease</a:t>
                      </a:r>
                      <a:endParaRPr lang="en-US" sz="1050" b="0" i="1" u="none" strike="noStrike" noProof="0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fi-FI" sz="16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is-IS" sz="16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is-IS" sz="16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3" name="CuadroTexto 2"/>
          <p:cNvSpPr txBox="1"/>
          <p:nvPr/>
        </p:nvSpPr>
        <p:spPr>
          <a:xfrm>
            <a:off x="339482" y="401488"/>
            <a:ext cx="86314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err="1" smtClean="0">
                <a:latin typeface="Arial"/>
                <a:cs typeface="Arial"/>
              </a:rPr>
              <a:t>Table</a:t>
            </a:r>
            <a:r>
              <a:rPr lang="es-ES" b="1" dirty="0" smtClean="0">
                <a:latin typeface="Arial"/>
                <a:cs typeface="Arial"/>
              </a:rPr>
              <a:t> S1: </a:t>
            </a:r>
            <a:r>
              <a:rPr lang="en-US" b="1" dirty="0" smtClean="0">
                <a:latin typeface="Arial"/>
                <a:cs typeface="Arial"/>
              </a:rPr>
              <a:t>Eigenvectors values for the three multimorbidity patterns identified</a:t>
            </a:r>
            <a:endParaRPr lang="es-ES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71683426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</TotalTime>
  <Words>82</Words>
  <Application>Microsoft Office PowerPoint</Application>
  <PresentationFormat>Presentación en pantalla (4:3)</PresentationFormat>
  <Paragraphs>44</Paragraphs>
  <Slides>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3" baseType="lpstr">
      <vt:lpstr>Tema de Office</vt:lpstr>
      <vt:lpstr>Diapositiva 1</vt:lpstr>
      <vt:lpstr>Diapositiva 2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na lydia rivera</dc:creator>
  <cp:lastModifiedBy>asalinas</cp:lastModifiedBy>
  <cp:revision>9</cp:revision>
  <dcterms:created xsi:type="dcterms:W3CDTF">2018-03-20T18:17:40Z</dcterms:created>
  <dcterms:modified xsi:type="dcterms:W3CDTF">2018-04-04T22:58:00Z</dcterms:modified>
</cp:coreProperties>
</file>